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F69CAA-14C9-4EDF-94EE-1A6E0448D7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ED47F2-E44B-46B2-94AE-A6B223566C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87439A-4597-4160-A57E-A58F9FD8F10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30B651-CD0A-40D6-BC07-186C1269DB8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F6AE2A-1F1D-4518-B159-3573BFCB9C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98836C-1A4C-4E29-B51C-52CA0CF6C7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475C8F-2341-446D-BFBD-06951C7D13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28A99-AAAD-4888-B0B8-96ABFAFB2C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9C2D03-57AB-4997-8EC5-7812106D4B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B9AA7A-97DF-49B5-9152-853CC64E50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481A1D-406E-46B0-928C-0F02E1B6DB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5E5C0D-5590-4D21-8EAE-B016D24DDA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2FE0B18-83D2-492A-B965-E2786C151B1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82760" y="293760"/>
            <a:ext cx="6987960" cy="5268240"/>
            <a:chOff x="482760" y="293760"/>
            <a:chExt cx="6987960" cy="5268240"/>
          </a:xfrm>
        </p:grpSpPr>
        <p:grpSp>
          <p:nvGrpSpPr>
            <p:cNvPr id="42" name=""/>
            <p:cNvGrpSpPr/>
            <p:nvPr/>
          </p:nvGrpSpPr>
          <p:grpSpPr>
            <a:xfrm>
              <a:off x="1527120" y="1206360"/>
              <a:ext cx="5943600" cy="4355640"/>
              <a:chOff x="1527120" y="1206360"/>
              <a:chExt cx="5943600" cy="4355640"/>
            </a:xfrm>
          </p:grpSpPr>
          <p:sp>
            <p:nvSpPr>
              <p:cNvPr id="43" name=""/>
              <p:cNvSpPr/>
              <p:nvPr/>
            </p:nvSpPr>
            <p:spPr>
              <a:xfrm>
                <a:off x="1527120" y="1216080"/>
                <a:ext cx="5943600" cy="4345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CCGTCGGCGCCGTCCTCGTCGTGCTCATCTCGGGTACGGGAGTGGTCCTGCGCGACCTGCGGCGCCGCCGGCGTCCGTGATCG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GGCAGCCGCGGCAGGAGCAGCACGAGTAGAGCCCATGCCCTCACCAGGACGCGCTGGACGCCGCGGCGGCCGCAGGCACTAG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CGGGGCGGCGGCGCGAGCACCGGCGTCACTCGGCGACGACGCCCCCGTCGCCCGGCGCCGGCTCCAGGTCGAACTCCCCGTC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GCCCCGCCGCCGCGCTCGTGGCCGC</a:t>
                </a:r>
                <a:r>
                  <a:rPr b="0" lang="en-US" sz="900" spc="-1" strike="noStrike" u="sng">
                    <a:solidFill>
                      <a:srgbClr val="000000"/>
                    </a:solidFill>
                    <a:uFillTx/>
                    <a:latin typeface="Courier New"/>
                  </a:rPr>
                  <a:t>AGT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GAGCCGCTGCTGCGGGGGCAGCGGGCCGCGGCCGAGGTCCAGCTTGAGGGGCAGG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                         </a:t>
                </a:r>
                <a:r>
                  <a:rPr b="0" i="1" lang="en-US" sz="900" spc="-1" strike="noStrike" u="sng">
                    <a:solidFill>
                      <a:srgbClr val="000000"/>
                    </a:solidFill>
                    <a:uFillTx/>
                    <a:latin typeface="Courier New"/>
                  </a:rPr>
                  <a:t>GAT</a:t>
                </a:r>
                <a:r>
                  <a:rPr b="0" i="1" lang="en-US" sz="900" spc="-1" strike="noStrike">
                    <a:solidFill>
                      <a:srgbClr val="000000"/>
                    </a:solidFill>
                    <a:latin typeface="Courier New"/>
                  </a:rPr>
                  <a:t>GAGCTGCAGCGGGGGCCTCGCGAGGCGCCGGCTGAGGTCCAGCTTGAGAGGCAGG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                          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***** ** ** * **   *    ***  **** *************** ******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CGCGCACCCAGGACGAAAGCCCGCCACTCCGCCTCGGTGTACCGCAGCACCGTCTCCGGATCCAGCGACGACCGCATGGCCA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GCGCGTGGGTCCTGCTTTCGGGCGGTGAGGCGGAGCCACATGGCGTCGTGGCAGAGGCCTAGGTCGCTGCTGGCGTACCGGTG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900" spc="-1" strike="noStrike">
                    <a:solidFill>
                      <a:srgbClr val="000000"/>
                    </a:solidFill>
                    <a:latin typeface="Courier New"/>
                  </a:rPr>
                  <a:t>GCGCGTGGCTCGTGCTTGCGGGCGGTGAGGCGGAGGCACATGGCGTCATGCCACAACACCAGCTCGCTGCTGGCGTAGCGCTG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******** ** ***** ***************** *********** ** ** **  * ** ************** ** **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GGCTCCGTCGGGCAGATAGGCGATCTCCACCCGCTCCTCGTGTTCCTCCGTCCCCGGCGCGCTGTGCCACTCCACACCCGAGA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CCGAGGCAGCCCGTCTATCCGCTAGAGGTGGGCGAGGAGCACAAGGAGGCAGGGGCCGCGCGACACGGTGAGGTGTGGGCTCT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900" spc="-1" strike="noStrike">
                    <a:solidFill>
                      <a:srgbClr val="000000"/>
                    </a:solidFill>
                    <a:latin typeface="Courier New"/>
                  </a:rPr>
                  <a:t>CCGTGGCAGGCCGTCCATCCGCTAGAGCTGGGCAAGGAGTACCCGGAGCCACGGCCCGCGCGACACGGTAAGCTGCGGGCTCT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*** *********** *********** ***** ***** **  **** ** ** ************** ** ** *******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TGTCGAGCGCGTACAGCTCGTCCCGCTCGCGCTCCTTGCGGGCTTTGACGTCCTCGTCCGGCACCTGGGCCATGGCGGAGGTG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ACAGCTCGCGCATGTCGAGCAGGGCGAGCGCGAGGAACGCCCGAAACTGCAGGAGCAGGCCGTGGACCCG</a:t>
                </a:r>
                <a:r>
                  <a:rPr b="0" lang="en-US" sz="900" spc="-1" strike="noStrike" u="sng">
                    <a:solidFill>
                      <a:srgbClr val="000000"/>
                    </a:solidFill>
                    <a:uFillTx/>
                    <a:latin typeface="Courier New"/>
                  </a:rPr>
                  <a:t>GTA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CCGCCTCCA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900" spc="-1" strike="noStrike">
                    <a:solidFill>
                      <a:srgbClr val="000000"/>
                    </a:solidFill>
                    <a:latin typeface="Courier New"/>
                  </a:rPr>
                  <a:t>ACAGCTCCCGCATCTCGAGCAGGGCGAGGGCCAGGAACGCACGAGCCTCAAGGAACAGGAGCCGGAGCCG</a:t>
                </a:r>
                <a:r>
                  <a:rPr b="0" i="1" lang="en-US" sz="900" spc="-1" strike="noStrike" u="sng">
                    <a:solidFill>
                      <a:srgbClr val="000000"/>
                    </a:solidFill>
                    <a:uFillTx/>
                    <a:latin typeface="Courier New"/>
                  </a:rPr>
                  <a:t>GTA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******* ***** ************** ** ******** ***  **  **** ****    *** ******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TCCTTTCAGGCGGCTTACCAACGATCCCCGACAACCTTACTGGCCCTGCCCCTGCCTCGGTGGCGGAAGCAGCCGACGGCCAC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Courier New"/>
                  </a:rPr>
                  <a:t>AGGAAAGTCCGCCGAATGGTTGCTAGGGGCTGTTGGAATGACCGGGACGGGGACGGAGCCACCGCCTTCGTCGGCTGCCGGTG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"/>
              <p:cNvSpPr/>
              <p:nvPr/>
            </p:nvSpPr>
            <p:spPr>
              <a:xfrm flipH="1" flipV="1">
                <a:off x="2495160" y="4541400"/>
                <a:ext cx="4105080" cy="12600"/>
              </a:xfrm>
              <a:prstGeom prst="line">
                <a:avLst/>
              </a:prstGeom>
              <a:ln w="3816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7242120" y="3730680"/>
                <a:ext cx="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 flipH="1">
                <a:off x="5857200" y="2081160"/>
                <a:ext cx="1411560" cy="0"/>
              </a:xfrm>
              <a:prstGeom prst="line">
                <a:avLst/>
              </a:prstGeom>
              <a:ln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 flipH="1">
                <a:off x="1617480" y="2906640"/>
                <a:ext cx="2666880" cy="0"/>
              </a:xfrm>
              <a:prstGeom prst="line">
                <a:avLst/>
              </a:prstGeom>
              <a:ln w="381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 flipH="1">
                <a:off x="1610640" y="2975040"/>
                <a:ext cx="4007160" cy="27000"/>
              </a:xfrm>
              <a:prstGeom prst="line">
                <a:avLst/>
              </a:prstGeom>
              <a:ln w="38160">
                <a:solidFill>
                  <a:srgbClr val="0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 flipH="1">
                <a:off x="7184520" y="2157480"/>
                <a:ext cx="106200" cy="0"/>
              </a:xfrm>
              <a:prstGeom prst="line">
                <a:avLst/>
              </a:prstGeom>
              <a:ln w="38160">
                <a:solidFill>
                  <a:srgbClr val="008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 flipH="1">
                <a:off x="1611000" y="1758960"/>
                <a:ext cx="2864160" cy="0"/>
              </a:xfrm>
              <a:prstGeom prst="line">
                <a:avLst/>
              </a:prstGeom>
              <a:ln w="38160">
                <a:solidFill>
                  <a:srgbClr val="ff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6076800" y="1220760"/>
                <a:ext cx="1155600" cy="0"/>
              </a:xfrm>
              <a:prstGeom prst="line">
                <a:avLst/>
              </a:prstGeom>
              <a:ln w="38160">
                <a:solidFill>
                  <a:srgbClr val="ff66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1639800" y="1206360"/>
                <a:ext cx="4033800" cy="0"/>
              </a:xfrm>
              <a:prstGeom prst="line">
                <a:avLst/>
              </a:prstGeom>
              <a:ln w="38160">
                <a:solidFill>
                  <a:srgbClr val="ff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3159000" y="5052960"/>
                <a:ext cx="3967200" cy="1440"/>
              </a:xfrm>
              <a:prstGeom prst="line">
                <a:avLst/>
              </a:prstGeom>
              <a:ln w="38160">
                <a:solidFill>
                  <a:srgbClr val="80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4" name=""/>
            <p:cNvSpPr/>
            <p:nvPr/>
          </p:nvSpPr>
          <p:spPr>
            <a:xfrm>
              <a:off x="1552680" y="2516040"/>
              <a:ext cx="5781600" cy="1692360"/>
            </a:xfrm>
            <a:prstGeom prst="rect">
              <a:avLst/>
            </a:prstGeom>
            <a:solidFill>
              <a:srgbClr val="ff9900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3289320" y="1654200"/>
              <a:ext cx="4048200" cy="858960"/>
            </a:xfrm>
            <a:prstGeom prst="rect">
              <a:avLst/>
            </a:prstGeom>
            <a:solidFill>
              <a:srgbClr val="ff9900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542960" y="4213080"/>
              <a:ext cx="5079960" cy="700200"/>
            </a:xfrm>
            <a:prstGeom prst="rect">
              <a:avLst/>
            </a:prstGeom>
            <a:solidFill>
              <a:srgbClr val="ff9900">
                <a:alpha val="25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82760" y="293760"/>
              <a:ext cx="143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Additional File 10.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05T14:08:03Z</dcterms:created>
  <dc:creator>Lewis</dc:creator>
  <dc:description/>
  <dc:language>en-US</dc:language>
  <cp:lastModifiedBy>Lewis</cp:lastModifiedBy>
  <cp:lastPrinted>2010-06-04T17:22:53Z</cp:lastPrinted>
  <dcterms:modified xsi:type="dcterms:W3CDTF">2010-09-24T14:22:11Z</dcterms:modified>
  <cp:revision>7</cp:revision>
  <dc:subject/>
  <dc:title>Slide 1</dc:title>
</cp:coreProperties>
</file>